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EC836-6358-4492-83F8-5E281199B4E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11ED6-B4C9-48AB-A239-3415389EFA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12FD8-DC9C-4390-828A-4396AF0D04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9E426-9B3B-451E-9A95-0AF3913FB0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E15BF-DDFB-4AC6-B75B-D9BE45B5B5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A9276-4205-497B-8F25-43E6AB7C13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15ACFB-216B-49D8-848F-C792FE1E3A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91C68-5E60-43CA-9A96-4439F65423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873030-8EBC-488C-8C75-07804C4613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C98D4-3D1D-4F66-8586-DE247E75AD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CD14A3-35E0-43A9-8D50-2755764D10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00E5E-B341-4270-AE79-D8D0AA397F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B0BEA9-2D94-41D5-99D4-E5085F7AB63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304920" y="4114800"/>
            <a:ext cx="6080040" cy="9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Sample result of threading of FLZ domain using Phyre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reading identified the relation of FLZ domain with LIM domain. The FLZ domain of At1g19200 protein is used as query in this study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rcRect l="0" t="10158" r="1249" b="10936"/>
          <a:stretch/>
        </p:blipFill>
        <p:spPr>
          <a:xfrm>
            <a:off x="380880" y="152280"/>
            <a:ext cx="6080400" cy="3886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17T06:11:06Z</dcterms:created>
  <dc:creator>NIPGR</dc:creator>
  <dc:description/>
  <dc:language>en-US</dc:language>
  <cp:lastModifiedBy>NIPGR</cp:lastModifiedBy>
  <dcterms:modified xsi:type="dcterms:W3CDTF">2014-05-13T07:25:34Z</dcterms:modified>
  <cp:revision>38</cp:revision>
  <dc:subject/>
  <dc:title>Slide 1</dc:title>
</cp:coreProperties>
</file>